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FD2AA4-A69F-4FC1-B233-1BA220204A9B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DB412E-836D-46B5-81DD-81DFF927E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9575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b="1" dirty="0"/>
              <a:t>Supplementary Table S2.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ssociation between two pathologists for labeling index of Tp53 (2+/3+),</a:t>
            </a:r>
            <a:r>
              <a:rPr lang="en-US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RB (2+/3+), and PTEN (1+/2+/3+)</a:t>
            </a:r>
          </a:p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ev1:</a:t>
            </a:r>
            <a:r>
              <a:rPr lang="en-US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Pathologist 1; Rev2: Pathologist 2</a:t>
            </a:r>
            <a:endParaRPr lang="en-US" dirty="0"/>
          </a:p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48055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916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413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169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197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34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632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786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192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271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613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603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4B00E-BC12-41D6-8A7E-733B833B3C58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45900-D0EE-4E3D-A9C2-A2AE501FF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412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/>
          </p:nvPr>
        </p:nvGraphicFramePr>
        <p:xfrm>
          <a:off x="2456330" y="2640997"/>
          <a:ext cx="6772588" cy="2641480"/>
        </p:xfrm>
        <a:graphic>
          <a:graphicData uri="http://schemas.openxmlformats.org/drawingml/2006/table">
            <a:tbl>
              <a:tblPr/>
              <a:tblGrid>
                <a:gridCol w="782123">
                  <a:extLst>
                    <a:ext uri="{9D8B030D-6E8A-4147-A177-3AD203B41FA5}">
                      <a16:colId xmlns:a16="http://schemas.microsoft.com/office/drawing/2014/main" val="2379194129"/>
                    </a:ext>
                  </a:extLst>
                </a:gridCol>
                <a:gridCol w="386857">
                  <a:extLst>
                    <a:ext uri="{9D8B030D-6E8A-4147-A177-3AD203B41FA5}">
                      <a16:colId xmlns:a16="http://schemas.microsoft.com/office/drawing/2014/main" val="4102217677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4057270573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2364028628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606021620"/>
                    </a:ext>
                  </a:extLst>
                </a:gridCol>
                <a:gridCol w="386857">
                  <a:extLst>
                    <a:ext uri="{9D8B030D-6E8A-4147-A177-3AD203B41FA5}">
                      <a16:colId xmlns:a16="http://schemas.microsoft.com/office/drawing/2014/main" val="2094362722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274218153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1793470466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3801936705"/>
                    </a:ext>
                  </a:extLst>
                </a:gridCol>
                <a:gridCol w="386857">
                  <a:extLst>
                    <a:ext uri="{9D8B030D-6E8A-4147-A177-3AD203B41FA5}">
                      <a16:colId xmlns:a16="http://schemas.microsoft.com/office/drawing/2014/main" val="1144226811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1290385526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1243095557"/>
                    </a:ext>
                  </a:extLst>
                </a:gridCol>
                <a:gridCol w="387457">
                  <a:extLst>
                    <a:ext uri="{9D8B030D-6E8A-4147-A177-3AD203B41FA5}">
                      <a16:colId xmlns:a16="http://schemas.microsoft.com/office/drawing/2014/main" val="1186508803"/>
                    </a:ext>
                  </a:extLst>
                </a:gridCol>
                <a:gridCol w="573677">
                  <a:extLst>
                    <a:ext uri="{9D8B030D-6E8A-4147-A177-3AD203B41FA5}">
                      <a16:colId xmlns:a16="http://schemas.microsoft.com/office/drawing/2014/main" val="1471065193"/>
                    </a:ext>
                  </a:extLst>
                </a:gridCol>
                <a:gridCol w="732865">
                  <a:extLst>
                    <a:ext uri="{9D8B030D-6E8A-4147-A177-3AD203B41FA5}">
                      <a16:colId xmlns:a16="http://schemas.microsoft.com/office/drawing/2014/main" val="3585729803"/>
                    </a:ext>
                  </a:extLst>
                </a:gridCol>
                <a:gridCol w="36239">
                  <a:extLst>
                    <a:ext uri="{9D8B030D-6E8A-4147-A177-3AD203B41FA5}">
                      <a16:colId xmlns:a16="http://schemas.microsoft.com/office/drawing/2014/main" val="3136754773"/>
                    </a:ext>
                  </a:extLst>
                </a:gridCol>
              </a:tblGrid>
              <a:tr h="14375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1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1 (Rev2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768345"/>
                  </a:ext>
                </a:extLst>
              </a:tr>
              <a:tr h="28751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3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3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6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9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7125874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4572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 (Rev1)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31, 0.67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4353271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7165991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2510682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2592188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4475804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4274179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118140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0993163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8653530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1054283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2365005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4834456"/>
                  </a:ext>
                </a:extLst>
              </a:tr>
              <a:tr h="143759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9441860"/>
                  </a:ext>
                </a:extLst>
              </a:tr>
              <a:tr h="287518">
                <a:tc gridSpan="13">
                  <a:txBody>
                    <a:bodyPr/>
                    <a:lstStyle/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4569068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2456323" y="4950264"/>
          <a:ext cx="6772595" cy="1907736"/>
        </p:xfrm>
        <a:graphic>
          <a:graphicData uri="http://schemas.openxmlformats.org/drawingml/2006/table">
            <a:tbl>
              <a:tblPr/>
              <a:tblGrid>
                <a:gridCol w="975362">
                  <a:extLst>
                    <a:ext uri="{9D8B030D-6E8A-4147-A177-3AD203B41FA5}">
                      <a16:colId xmlns:a16="http://schemas.microsoft.com/office/drawing/2014/main" val="2916007238"/>
                    </a:ext>
                  </a:extLst>
                </a:gridCol>
                <a:gridCol w="418058">
                  <a:extLst>
                    <a:ext uri="{9D8B030D-6E8A-4147-A177-3AD203B41FA5}">
                      <a16:colId xmlns:a16="http://schemas.microsoft.com/office/drawing/2014/main" val="2448963396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425372520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4209598838"/>
                    </a:ext>
                  </a:extLst>
                </a:gridCol>
                <a:gridCol w="418058">
                  <a:extLst>
                    <a:ext uri="{9D8B030D-6E8A-4147-A177-3AD203B41FA5}">
                      <a16:colId xmlns:a16="http://schemas.microsoft.com/office/drawing/2014/main" val="25577379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4069010351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320422378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1510216280"/>
                    </a:ext>
                  </a:extLst>
                </a:gridCol>
                <a:gridCol w="418058">
                  <a:extLst>
                    <a:ext uri="{9D8B030D-6E8A-4147-A177-3AD203B41FA5}">
                      <a16:colId xmlns:a16="http://schemas.microsoft.com/office/drawing/2014/main" val="855923578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1530906035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2677170570"/>
                    </a:ext>
                  </a:extLst>
                </a:gridCol>
                <a:gridCol w="418689">
                  <a:extLst>
                    <a:ext uri="{9D8B030D-6E8A-4147-A177-3AD203B41FA5}">
                      <a16:colId xmlns:a16="http://schemas.microsoft.com/office/drawing/2014/main" val="712881494"/>
                    </a:ext>
                  </a:extLst>
                </a:gridCol>
                <a:gridCol w="454685">
                  <a:extLst>
                    <a:ext uri="{9D8B030D-6E8A-4147-A177-3AD203B41FA5}">
                      <a16:colId xmlns:a16="http://schemas.microsoft.com/office/drawing/2014/main" val="3789441369"/>
                    </a:ext>
                  </a:extLst>
                </a:gridCol>
                <a:gridCol w="738862">
                  <a:extLst>
                    <a:ext uri="{9D8B030D-6E8A-4147-A177-3AD203B41FA5}">
                      <a16:colId xmlns:a16="http://schemas.microsoft.com/office/drawing/2014/main" val="1592732154"/>
                    </a:ext>
                  </a:extLst>
                </a:gridCol>
              </a:tblGrid>
              <a:tr h="12895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1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 (Rev2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590943"/>
                  </a:ext>
                </a:extLst>
              </a:tr>
              <a:tr h="2579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3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4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6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2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6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23832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4572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EN (Rev1)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75, 0.92)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98111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9182359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4355409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887796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032278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9371345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341196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4630833"/>
                  </a:ext>
                </a:extLst>
              </a:tr>
              <a:tr h="128954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259182"/>
                  </a:ext>
                </a:extLst>
              </a:tr>
              <a:tr h="128954">
                <a:tc gridSpan="12">
                  <a:txBody>
                    <a:bodyPr/>
                    <a:lstStyle/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5461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4865322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/>
          </p:nvPr>
        </p:nvGraphicFramePr>
        <p:xfrm>
          <a:off x="2456322" y="146265"/>
          <a:ext cx="6772595" cy="2511051"/>
        </p:xfrm>
        <a:graphic>
          <a:graphicData uri="http://schemas.openxmlformats.org/drawingml/2006/table">
            <a:tbl>
              <a:tblPr firstRow="1" firstCol="1" bandRow="1"/>
              <a:tblGrid>
                <a:gridCol w="879716">
                  <a:extLst>
                    <a:ext uri="{9D8B030D-6E8A-4147-A177-3AD203B41FA5}">
                      <a16:colId xmlns:a16="http://schemas.microsoft.com/office/drawing/2014/main" val="4043388306"/>
                    </a:ext>
                  </a:extLst>
                </a:gridCol>
                <a:gridCol w="410491">
                  <a:extLst>
                    <a:ext uri="{9D8B030D-6E8A-4147-A177-3AD203B41FA5}">
                      <a16:colId xmlns:a16="http://schemas.microsoft.com/office/drawing/2014/main" val="205743158"/>
                    </a:ext>
                  </a:extLst>
                </a:gridCol>
                <a:gridCol w="347188">
                  <a:extLst>
                    <a:ext uri="{9D8B030D-6E8A-4147-A177-3AD203B41FA5}">
                      <a16:colId xmlns:a16="http://schemas.microsoft.com/office/drawing/2014/main" val="3732464615"/>
                    </a:ext>
                  </a:extLst>
                </a:gridCol>
                <a:gridCol w="347188">
                  <a:extLst>
                    <a:ext uri="{9D8B030D-6E8A-4147-A177-3AD203B41FA5}">
                      <a16:colId xmlns:a16="http://schemas.microsoft.com/office/drawing/2014/main" val="1866263221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746024315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1634557621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3429866084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2985703088"/>
                    </a:ext>
                  </a:extLst>
                </a:gridCol>
                <a:gridCol w="281927">
                  <a:extLst>
                    <a:ext uri="{9D8B030D-6E8A-4147-A177-3AD203B41FA5}">
                      <a16:colId xmlns:a16="http://schemas.microsoft.com/office/drawing/2014/main" val="67561674"/>
                    </a:ext>
                  </a:extLst>
                </a:gridCol>
                <a:gridCol w="43551">
                  <a:extLst>
                    <a:ext uri="{9D8B030D-6E8A-4147-A177-3AD203B41FA5}">
                      <a16:colId xmlns:a16="http://schemas.microsoft.com/office/drawing/2014/main" val="796338104"/>
                    </a:ext>
                  </a:extLst>
                </a:gridCol>
                <a:gridCol w="43551">
                  <a:extLst>
                    <a:ext uri="{9D8B030D-6E8A-4147-A177-3AD203B41FA5}">
                      <a16:colId xmlns:a16="http://schemas.microsoft.com/office/drawing/2014/main" val="400222501"/>
                    </a:ext>
                  </a:extLst>
                </a:gridCol>
                <a:gridCol w="286016">
                  <a:extLst>
                    <a:ext uri="{9D8B030D-6E8A-4147-A177-3AD203B41FA5}">
                      <a16:colId xmlns:a16="http://schemas.microsoft.com/office/drawing/2014/main" val="1356152972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742395960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1655662259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3761207163"/>
                    </a:ext>
                  </a:extLst>
                </a:gridCol>
                <a:gridCol w="347840">
                  <a:extLst>
                    <a:ext uri="{9D8B030D-6E8A-4147-A177-3AD203B41FA5}">
                      <a16:colId xmlns:a16="http://schemas.microsoft.com/office/drawing/2014/main" val="2963216998"/>
                    </a:ext>
                  </a:extLst>
                </a:gridCol>
                <a:gridCol w="348493">
                  <a:extLst>
                    <a:ext uri="{9D8B030D-6E8A-4147-A177-3AD203B41FA5}">
                      <a16:colId xmlns:a16="http://schemas.microsoft.com/office/drawing/2014/main" val="2022662965"/>
                    </a:ext>
                  </a:extLst>
                </a:gridCol>
                <a:gridCol w="355672">
                  <a:extLst>
                    <a:ext uri="{9D8B030D-6E8A-4147-A177-3AD203B41FA5}">
                      <a16:colId xmlns:a16="http://schemas.microsoft.com/office/drawing/2014/main" val="4268499468"/>
                    </a:ext>
                  </a:extLst>
                </a:gridCol>
                <a:gridCol w="646082">
                  <a:extLst>
                    <a:ext uri="{9D8B030D-6E8A-4147-A177-3AD203B41FA5}">
                      <a16:colId xmlns:a16="http://schemas.microsoft.com/office/drawing/2014/main" val="23951721"/>
                    </a:ext>
                  </a:extLst>
                </a:gridCol>
              </a:tblGrid>
              <a:tr h="0">
                <a:tc gridSpan="8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                                                                                  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p53 (Rev2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40577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8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3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4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6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  <a:b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b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)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3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3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</a:t>
                      </a:r>
                      <a:b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</a:b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5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appa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% (CI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83527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p53 (Rev1)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8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0.68, 0.88)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00447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34542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2552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7406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29717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14581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0691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59111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16185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21175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8379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79689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50102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109855" marR="0" indent="109855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65225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1879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9</Words>
  <Application>Microsoft Office PowerPoint</Application>
  <PresentationFormat>Widescreen</PresentationFormat>
  <Paragraphs>6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VA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cuse, Paul *HS</dc:creator>
  <cp:lastModifiedBy>Viscuse, Paul *HS</cp:lastModifiedBy>
  <cp:revision>1</cp:revision>
  <dcterms:created xsi:type="dcterms:W3CDTF">2023-09-07T19:39:39Z</dcterms:created>
  <dcterms:modified xsi:type="dcterms:W3CDTF">2023-09-07T19:39:45Z</dcterms:modified>
</cp:coreProperties>
</file>